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CAB3DDA-6647-432F-B72B-5C9FFCA87A8B}" v="2" dt="2021-11-26T02:34:18.40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 ki" userId="3b684e08510dea98" providerId="LiveId" clId="{0CAB3DDA-6647-432F-B72B-5C9FFCA87A8B}"/>
    <pc:docChg chg="custSel modSld">
      <pc:chgData name="mi ki" userId="3b684e08510dea98" providerId="LiveId" clId="{0CAB3DDA-6647-432F-B72B-5C9FFCA87A8B}" dt="2021-11-26T02:34:51.304" v="10" actId="1076"/>
      <pc:docMkLst>
        <pc:docMk/>
      </pc:docMkLst>
      <pc:sldChg chg="addSp delSp modSp mod">
        <pc:chgData name="mi ki" userId="3b684e08510dea98" providerId="LiveId" clId="{0CAB3DDA-6647-432F-B72B-5C9FFCA87A8B}" dt="2021-11-26T02:34:51.304" v="10" actId="1076"/>
        <pc:sldMkLst>
          <pc:docMk/>
          <pc:sldMk cId="3277990495" sldId="256"/>
        </pc:sldMkLst>
        <pc:spChg chg="mod ord">
          <ac:chgData name="mi ki" userId="3b684e08510dea98" providerId="LiveId" clId="{0CAB3DDA-6647-432F-B72B-5C9FFCA87A8B}" dt="2021-11-26T02:34:51.304" v="10" actId="1076"/>
          <ac:spMkLst>
            <pc:docMk/>
            <pc:sldMk cId="3277990495" sldId="256"/>
            <ac:spMk id="6" creationId="{CECD2AC1-42ED-4A2E-A142-192484CF66D5}"/>
          </ac:spMkLst>
        </pc:spChg>
        <pc:picChg chg="add mod">
          <ac:chgData name="mi ki" userId="3b684e08510dea98" providerId="LiveId" clId="{0CAB3DDA-6647-432F-B72B-5C9FFCA87A8B}" dt="2021-11-26T02:34:34.720" v="8" actId="1076"/>
          <ac:picMkLst>
            <pc:docMk/>
            <pc:sldMk cId="3277990495" sldId="256"/>
            <ac:picMk id="3" creationId="{1FFA9182-27F6-450B-B229-AEDEA7420007}"/>
          </ac:picMkLst>
        </pc:picChg>
        <pc:picChg chg="del">
          <ac:chgData name="mi ki" userId="3b684e08510dea98" providerId="LiveId" clId="{0CAB3DDA-6647-432F-B72B-5C9FFCA87A8B}" dt="2021-11-26T02:33:43.795" v="0" actId="478"/>
          <ac:picMkLst>
            <pc:docMk/>
            <pc:sldMk cId="3277990495" sldId="256"/>
            <ac:picMk id="5" creationId="{5E72777B-87ED-4E8B-844C-B8239941CE9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9C272E-E7E8-44BD-A340-8FA0B1C0F7B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D5A3627-6435-42B6-90EB-61CC954AA3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47D7B9-3D6E-48CF-B923-D8E7E9FD7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C53E86-6E26-48A7-9F0B-6C59B719F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55DA2A-F4B5-495E-9024-CBB99EC4D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3699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D69D81-89A1-490F-80FE-368BF90D20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4F157E8-C9B2-4902-A3D0-5E69263B07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3A43A0-5007-4C2C-B4EF-AE1983F91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4FDACB-B493-4BB8-8609-E89C20093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C16A19-722B-456B-B7E7-1BFA763979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4859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198E2D1-A18A-45AB-9A64-BB9FD697D8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59894B9-38A5-4581-8BD6-35E81036A9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3317CF-3E44-49A6-B416-A3B7DDD75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7FA7475-0E39-4DF8-833B-803587D16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BA7F7AD-3011-4984-97B5-56A9CF8A7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2692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5BC3E74-A6A4-4699-BB2E-366056607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D74F552-7F98-458C-B5C6-D7661D9940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CA1C24-B0D3-4FB0-9203-376280C4B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1513EB-7CA8-4009-9FA4-CA67B49EB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823EBD-C6A1-4B04-9501-2A8BB5FAE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6713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FA0B3D-7744-4D95-ADC8-A0D5584DB2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0D099E7-8748-416F-B78B-CD099F9D90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787F1A-AA62-4DEF-9779-AACB5F05D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34CFBC-26F3-4A5D-9439-F1C5792F2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620191D-E837-41AC-831C-C0F1CA0DD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8451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DC7EA8-6CD3-4522-BBD0-761C13B324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D108D4F-45B5-408E-9580-F728844D4F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BF05545-5C2C-456A-BBE8-DA369E16EF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3BD0FC7-CB0D-41BD-AC8C-4477481F8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9AC82E7-94F0-4902-9946-2D5768799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CF71508-AEB6-45C2-9AD3-D6E2DC34F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8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53B130-2778-40DF-95E3-45DC53404B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0670444-9087-4123-B19B-A609D45A8A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F04F82D-9E53-4950-B29B-AB492B544D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4028503-5661-41AB-8568-8AA7074C79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D08F3F2-9400-469C-9961-AFB073AD91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7A66559-C2C3-400A-98E0-59DD9BA03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8ECDFCF-0629-440F-9D03-A60CA95FC6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3082482-9809-4FCF-8BFD-73FD323A9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170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987B56-8EAB-4A24-8F5B-B277A8CEB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DD3E5C4-55CD-48B2-B8F3-4A6165908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2A814F8-799B-425B-9818-F63A7AE40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3F49193-76FA-421E-9E00-ED4CF1B17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999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3F84EC5-BAE0-44F3-A78D-E7AF8B8F3F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2D110DE-5BFE-4E17-87AC-1F6111758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8502689-90A4-4716-AB8C-C8A550F64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8493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8AD96C-7F94-4F05-90FB-628D6B5309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594D86C-91EB-4B56-94F8-90816F6604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61449FF-3EC5-4911-B0D2-B4FEDCC88C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1D33AC-3168-44C4-9C0A-9D21C7EBC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BD313D-E021-427B-8F51-C2DDFAEE1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CDDAB20-55B4-4DAB-9CF3-2A1ECAD6E4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9565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69E41D-CDB2-48EF-9F19-27D5A6EE9C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F4D9A69-1CB5-47E0-A8A7-8CC2169364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4ED73AD-7D94-46F7-AB10-4E38951B7E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84EA6A0-7CBD-49BA-A4FF-D507C16B9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0BAC673-625E-4C02-AB59-3CDA65E0E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AAAF5F6-5C4D-4E3B-B12C-283601D33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0417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C92FDBE-738B-4A84-8D44-FA7CFBFC6C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988791D-272D-4A8D-8EBB-9399500916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37DC874-7550-43EE-A530-DA4E0C6AB4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12B2BE-2B49-4AC8-B1F8-93FAA517A184}" type="datetimeFigureOut">
              <a:rPr lang="zh-CN" altLang="en-US" smtClean="0"/>
              <a:t>2021/1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8106907-D62F-4F62-AD7F-A4BA4FAF96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E9DD03-101B-4503-978C-59B4B57E49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91EE40-0C71-449A-AB4A-513C2888CAF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6373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表&#10;&#10;描述已自动生成">
            <a:extLst>
              <a:ext uri="{FF2B5EF4-FFF2-40B4-BE49-F238E27FC236}">
                <a16:creationId xmlns:a16="http://schemas.microsoft.com/office/drawing/2014/main" id="{1FFA9182-27F6-450B-B229-AEDEA74200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62806" y="245805"/>
            <a:ext cx="9703517" cy="558899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ECD2AC1-42ED-4A2E-A142-192484CF66D5}"/>
              </a:ext>
            </a:extLst>
          </p:cNvPr>
          <p:cNvSpPr txBox="1"/>
          <p:nvPr/>
        </p:nvSpPr>
        <p:spPr>
          <a:xfrm>
            <a:off x="1425677" y="5469168"/>
            <a:ext cx="918809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ure 1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. Points of subjective equality (A) and Weber fractions (B) in five sessions (non-stimulus, 100-ms non-painful, 300-ms non-painful, 100-ms painful, 300-ms painful). The PSE and WF did not differ among these five session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779904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7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冬 月</dc:creator>
  <cp:lastModifiedBy>冬 月</cp:lastModifiedBy>
  <cp:revision>2</cp:revision>
  <dcterms:created xsi:type="dcterms:W3CDTF">2021-11-23T03:31:41Z</dcterms:created>
  <dcterms:modified xsi:type="dcterms:W3CDTF">2021-11-28T04:38:02Z</dcterms:modified>
</cp:coreProperties>
</file>